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9" r:id="rId2"/>
    <p:sldId id="261" r:id="rId3"/>
    <p:sldId id="260" r:id="rId4"/>
    <p:sldId id="26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818813B-73AD-2344-8D97-E478523C7736}" v="28" dt="2025-04-10T03:56:42.77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72"/>
    <p:restoredTop sz="94608"/>
  </p:normalViewPr>
  <p:slideViewPr>
    <p:cSldViewPr snapToGrid="0">
      <p:cViewPr>
        <p:scale>
          <a:sx n="76" d="100"/>
          <a:sy n="76" d="100"/>
        </p:scale>
        <p:origin x="2288" y="3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肇 松島" userId="95d768673f73624d" providerId="LiveId" clId="{165E880E-374A-0944-BA0B-4DEBE1ACF5DC}"/>
    <pc:docChg chg="custSel addSld modSld">
      <pc:chgData name="肇 松島" userId="95d768673f73624d" providerId="LiveId" clId="{165E880E-374A-0944-BA0B-4DEBE1ACF5DC}" dt="2024-09-16T06:04:29.155" v="216" actId="1037"/>
      <pc:docMkLst>
        <pc:docMk/>
      </pc:docMkLst>
      <pc:sldChg chg="addSp modSp mod">
        <pc:chgData name="肇 松島" userId="95d768673f73624d" providerId="LiveId" clId="{165E880E-374A-0944-BA0B-4DEBE1ACF5DC}" dt="2024-09-16T06:04:29.155" v="216" actId="1037"/>
        <pc:sldMkLst>
          <pc:docMk/>
          <pc:sldMk cId="986271506" sldId="258"/>
        </pc:sldMkLst>
      </pc:sldChg>
      <pc:sldChg chg="addSp delSp modSp new mod">
        <pc:chgData name="肇 松島" userId="95d768673f73624d" providerId="LiveId" clId="{165E880E-374A-0944-BA0B-4DEBE1ACF5DC}" dt="2024-09-16T06:00:33.310" v="183" actId="1036"/>
        <pc:sldMkLst>
          <pc:docMk/>
          <pc:sldMk cId="2843995754" sldId="260"/>
        </pc:sldMkLst>
      </pc:sldChg>
    </pc:docChg>
  </pc:docChgLst>
  <pc:docChgLst>
    <pc:chgData name="肇 松島" userId="95d768673f73624d" providerId="LiveId" clId="{4818813B-73AD-2344-8D97-E478523C7736}"/>
    <pc:docChg chg="custSel addSld modSld">
      <pc:chgData name="肇 松島" userId="95d768673f73624d" providerId="LiveId" clId="{4818813B-73AD-2344-8D97-E478523C7736}" dt="2025-04-10T03:57:07.935" v="531" actId="1076"/>
      <pc:docMkLst>
        <pc:docMk/>
      </pc:docMkLst>
      <pc:sldChg chg="addSp delSp modSp new mod">
        <pc:chgData name="肇 松島" userId="95d768673f73624d" providerId="LiveId" clId="{4818813B-73AD-2344-8D97-E478523C7736}" dt="2025-04-06T05:56:10.760" v="276" actId="20577"/>
        <pc:sldMkLst>
          <pc:docMk/>
          <pc:sldMk cId="232311950" sldId="260"/>
        </pc:sldMkLst>
        <pc:spChg chg="add mod">
          <ac:chgData name="肇 松島" userId="95d768673f73624d" providerId="LiveId" clId="{4818813B-73AD-2344-8D97-E478523C7736}" dt="2025-04-06T05:56:10.760" v="276" actId="20577"/>
          <ac:spMkLst>
            <pc:docMk/>
            <pc:sldMk cId="232311950" sldId="260"/>
            <ac:spMk id="4" creationId="{8F3718A0-AD90-2548-BA11-6DD545835CEA}"/>
          </ac:spMkLst>
        </pc:spChg>
        <pc:spChg chg="add mod">
          <ac:chgData name="肇 松島" userId="95d768673f73624d" providerId="LiveId" clId="{4818813B-73AD-2344-8D97-E478523C7736}" dt="2025-04-02T11:39:04.403" v="141" actId="20577"/>
          <ac:spMkLst>
            <pc:docMk/>
            <pc:sldMk cId="232311950" sldId="260"/>
            <ac:spMk id="8" creationId="{E62C88CF-9782-55C8-168F-09A43141C5DD}"/>
          </ac:spMkLst>
        </pc:spChg>
        <pc:spChg chg="add mod">
          <ac:chgData name="肇 松島" userId="95d768673f73624d" providerId="LiveId" clId="{4818813B-73AD-2344-8D97-E478523C7736}" dt="2025-04-02T11:40:48.113" v="200" actId="1076"/>
          <ac:spMkLst>
            <pc:docMk/>
            <pc:sldMk cId="232311950" sldId="260"/>
            <ac:spMk id="9" creationId="{36053E2D-118B-C603-F18D-63851875F959}"/>
          </ac:spMkLst>
        </pc:spChg>
        <pc:spChg chg="add mod">
          <ac:chgData name="肇 松島" userId="95d768673f73624d" providerId="LiveId" clId="{4818813B-73AD-2344-8D97-E478523C7736}" dt="2025-04-02T11:39:51.417" v="165" actId="20577"/>
          <ac:spMkLst>
            <pc:docMk/>
            <pc:sldMk cId="232311950" sldId="260"/>
            <ac:spMk id="10" creationId="{8BBA674A-BEBD-5DCA-386D-98B9F37E1222}"/>
          </ac:spMkLst>
        </pc:spChg>
        <pc:spChg chg="add mod">
          <ac:chgData name="肇 松島" userId="95d768673f73624d" providerId="LiveId" clId="{4818813B-73AD-2344-8D97-E478523C7736}" dt="2025-04-02T11:40:01.350" v="175" actId="20577"/>
          <ac:spMkLst>
            <pc:docMk/>
            <pc:sldMk cId="232311950" sldId="260"/>
            <ac:spMk id="11" creationId="{0601D4FB-7DAD-EBF1-8F30-97F0C481B72C}"/>
          </ac:spMkLst>
        </pc:spChg>
        <pc:spChg chg="add mod">
          <ac:chgData name="肇 松島" userId="95d768673f73624d" providerId="LiveId" clId="{4818813B-73AD-2344-8D97-E478523C7736}" dt="2025-04-02T11:40:41.697" v="199" actId="1076"/>
          <ac:spMkLst>
            <pc:docMk/>
            <pc:sldMk cId="232311950" sldId="260"/>
            <ac:spMk id="12" creationId="{68B9B63C-B782-D1BB-1566-5F961F2DF08F}"/>
          </ac:spMkLst>
        </pc:spChg>
        <pc:spChg chg="add mod">
          <ac:chgData name="肇 松島" userId="95d768673f73624d" providerId="LiveId" clId="{4818813B-73AD-2344-8D97-E478523C7736}" dt="2025-04-02T11:40:28.968" v="192" actId="1076"/>
          <ac:spMkLst>
            <pc:docMk/>
            <pc:sldMk cId="232311950" sldId="260"/>
            <ac:spMk id="13" creationId="{05B3EA19-36D2-334D-C00B-94D28A873707}"/>
          </ac:spMkLst>
        </pc:spChg>
        <pc:spChg chg="add mod">
          <ac:chgData name="肇 松島" userId="95d768673f73624d" providerId="LiveId" clId="{4818813B-73AD-2344-8D97-E478523C7736}" dt="2025-04-02T11:40:37.220" v="198" actId="20577"/>
          <ac:spMkLst>
            <pc:docMk/>
            <pc:sldMk cId="232311950" sldId="260"/>
            <ac:spMk id="14" creationId="{19BA9313-1951-EBE2-73C1-7F6B1FF28204}"/>
          </ac:spMkLst>
        </pc:spChg>
        <pc:spChg chg="add mod">
          <ac:chgData name="肇 松島" userId="95d768673f73624d" providerId="LiveId" clId="{4818813B-73AD-2344-8D97-E478523C7736}" dt="2025-04-02T11:41:46.676" v="239" actId="255"/>
          <ac:spMkLst>
            <pc:docMk/>
            <pc:sldMk cId="232311950" sldId="260"/>
            <ac:spMk id="17" creationId="{A96F5267-8C86-BE5A-3985-D0FDF44C2B25}"/>
          </ac:spMkLst>
        </pc:spChg>
        <pc:spChg chg="add mod">
          <ac:chgData name="肇 松島" userId="95d768673f73624d" providerId="LiveId" clId="{4818813B-73AD-2344-8D97-E478523C7736}" dt="2025-04-02T11:42:15.197" v="260" actId="20577"/>
          <ac:spMkLst>
            <pc:docMk/>
            <pc:sldMk cId="232311950" sldId="260"/>
            <ac:spMk id="20" creationId="{4E41351A-D23B-C270-6145-460A80FDCE68}"/>
          </ac:spMkLst>
        </pc:spChg>
        <pc:spChg chg="add mod">
          <ac:chgData name="肇 松島" userId="95d768673f73624d" providerId="LiveId" clId="{4818813B-73AD-2344-8D97-E478523C7736}" dt="2025-04-02T11:43:00.939" v="263" actId="208"/>
          <ac:spMkLst>
            <pc:docMk/>
            <pc:sldMk cId="232311950" sldId="260"/>
            <ac:spMk id="21" creationId="{A81E9D95-0FAA-81AF-8389-37073524646A}"/>
          </ac:spMkLst>
        </pc:spChg>
        <pc:spChg chg="add mod">
          <ac:chgData name="肇 松島" userId="95d768673f73624d" providerId="LiveId" clId="{4818813B-73AD-2344-8D97-E478523C7736}" dt="2025-04-02T11:43:14.774" v="268" actId="1076"/>
          <ac:spMkLst>
            <pc:docMk/>
            <pc:sldMk cId="232311950" sldId="260"/>
            <ac:spMk id="22" creationId="{41ED828A-615E-D26E-69CA-B2133640B8A8}"/>
          </ac:spMkLst>
        </pc:spChg>
        <pc:spChg chg="add mod">
          <ac:chgData name="肇 松島" userId="95d768673f73624d" providerId="LiveId" clId="{4818813B-73AD-2344-8D97-E478523C7736}" dt="2025-04-02T11:43:20.616" v="272" actId="20577"/>
          <ac:spMkLst>
            <pc:docMk/>
            <pc:sldMk cId="232311950" sldId="260"/>
            <ac:spMk id="23" creationId="{F2F69FD8-5DBE-5A23-647B-24AAFF3F5801}"/>
          </ac:spMkLst>
        </pc:spChg>
        <pc:picChg chg="add mod modCrop">
          <ac:chgData name="肇 松島" userId="95d768673f73624d" providerId="LiveId" clId="{4818813B-73AD-2344-8D97-E478523C7736}" dt="2025-04-02T11:38:37.800" v="137" actId="732"/>
          <ac:picMkLst>
            <pc:docMk/>
            <pc:sldMk cId="232311950" sldId="260"/>
            <ac:picMk id="5" creationId="{6E2F5C25-78AE-63CF-1481-46087A792728}"/>
          </ac:picMkLst>
        </pc:picChg>
        <pc:picChg chg="add mod modCrop">
          <ac:chgData name="肇 松島" userId="95d768673f73624d" providerId="LiveId" clId="{4818813B-73AD-2344-8D97-E478523C7736}" dt="2025-04-02T11:39:14.388" v="144" actId="1035"/>
          <ac:picMkLst>
            <pc:docMk/>
            <pc:sldMk cId="232311950" sldId="260"/>
            <ac:picMk id="6" creationId="{43166489-E7D6-8300-C398-CD3D85A9281E}"/>
          </ac:picMkLst>
        </pc:picChg>
        <pc:picChg chg="add mod modCrop">
          <ac:chgData name="肇 松島" userId="95d768673f73624d" providerId="LiveId" clId="{4818813B-73AD-2344-8D97-E478523C7736}" dt="2025-04-02T11:39:10.664" v="143" actId="1035"/>
          <ac:picMkLst>
            <pc:docMk/>
            <pc:sldMk cId="232311950" sldId="260"/>
            <ac:picMk id="7" creationId="{C4087712-D611-84E7-4BD9-B57C2B210ACE}"/>
          </ac:picMkLst>
        </pc:picChg>
        <pc:cxnChg chg="add mod">
          <ac:chgData name="肇 松島" userId="95d768673f73624d" providerId="LiveId" clId="{4818813B-73AD-2344-8D97-E478523C7736}" dt="2025-04-02T11:41:15.117" v="203" actId="1076"/>
          <ac:cxnSpMkLst>
            <pc:docMk/>
            <pc:sldMk cId="232311950" sldId="260"/>
            <ac:cxnSpMk id="16" creationId="{B8E13737-34B4-437E-44F8-99BFD166BA08}"/>
          </ac:cxnSpMkLst>
        </pc:cxnChg>
        <pc:cxnChg chg="add mod">
          <ac:chgData name="肇 松島" userId="95d768673f73624d" providerId="LiveId" clId="{4818813B-73AD-2344-8D97-E478523C7736}" dt="2025-04-02T11:43:24.139" v="273" actId="14100"/>
          <ac:cxnSpMkLst>
            <pc:docMk/>
            <pc:sldMk cId="232311950" sldId="260"/>
            <ac:cxnSpMk id="18" creationId="{CE756200-E382-659F-5F3B-9AE001BEECD7}"/>
          </ac:cxnSpMkLst>
        </pc:cxnChg>
      </pc:sldChg>
      <pc:sldChg chg="addSp delSp modSp new mod">
        <pc:chgData name="肇 松島" userId="95d768673f73624d" providerId="LiveId" clId="{4818813B-73AD-2344-8D97-E478523C7736}" dt="2025-04-06T06:06:32.211" v="425" actId="20577"/>
        <pc:sldMkLst>
          <pc:docMk/>
          <pc:sldMk cId="91462556" sldId="261"/>
        </pc:sldMkLst>
        <pc:spChg chg="add mod">
          <ac:chgData name="肇 松島" userId="95d768673f73624d" providerId="LiveId" clId="{4818813B-73AD-2344-8D97-E478523C7736}" dt="2025-04-06T05:56:50.757" v="366" actId="20577"/>
          <ac:spMkLst>
            <pc:docMk/>
            <pc:sldMk cId="91462556" sldId="261"/>
            <ac:spMk id="4" creationId="{841A1ABA-1644-0001-BF14-B7D5A457A067}"/>
          </ac:spMkLst>
        </pc:spChg>
        <pc:spChg chg="add mod">
          <ac:chgData name="肇 松島" userId="95d768673f73624d" providerId="LiveId" clId="{4818813B-73AD-2344-8D97-E478523C7736}" dt="2025-04-06T06:02:46.237" v="402" actId="1036"/>
          <ac:spMkLst>
            <pc:docMk/>
            <pc:sldMk cId="91462556" sldId="261"/>
            <ac:spMk id="7" creationId="{0DB7C083-7FEA-7E14-B5A3-B507670FBA9D}"/>
          </ac:spMkLst>
        </pc:spChg>
        <pc:spChg chg="add mod">
          <ac:chgData name="肇 松島" userId="95d768673f73624d" providerId="LiveId" clId="{4818813B-73AD-2344-8D97-E478523C7736}" dt="2025-04-06T06:02:46.237" v="402" actId="1036"/>
          <ac:spMkLst>
            <pc:docMk/>
            <pc:sldMk cId="91462556" sldId="261"/>
            <ac:spMk id="8" creationId="{2B11CE36-285B-9F83-486A-2F7286E22BB1}"/>
          </ac:spMkLst>
        </pc:spChg>
        <pc:spChg chg="add mod">
          <ac:chgData name="肇 松島" userId="95d768673f73624d" providerId="LiveId" clId="{4818813B-73AD-2344-8D97-E478523C7736}" dt="2025-04-06T06:02:46.237" v="402" actId="1036"/>
          <ac:spMkLst>
            <pc:docMk/>
            <pc:sldMk cId="91462556" sldId="261"/>
            <ac:spMk id="9" creationId="{9F8863CA-8F0C-3C26-9B41-C89FB1B35608}"/>
          </ac:spMkLst>
        </pc:spChg>
        <pc:spChg chg="add mod">
          <ac:chgData name="肇 松島" userId="95d768673f73624d" providerId="LiveId" clId="{4818813B-73AD-2344-8D97-E478523C7736}" dt="2025-04-06T06:02:46.237" v="402" actId="1036"/>
          <ac:spMkLst>
            <pc:docMk/>
            <pc:sldMk cId="91462556" sldId="261"/>
            <ac:spMk id="10" creationId="{335C8655-C7F2-E750-CE14-8ACA68D90456}"/>
          </ac:spMkLst>
        </pc:spChg>
        <pc:spChg chg="add mod">
          <ac:chgData name="肇 松島" userId="95d768673f73624d" providerId="LiveId" clId="{4818813B-73AD-2344-8D97-E478523C7736}" dt="2025-04-06T06:03:16.400" v="417" actId="207"/>
          <ac:spMkLst>
            <pc:docMk/>
            <pc:sldMk cId="91462556" sldId="261"/>
            <ac:spMk id="11" creationId="{D4EF24E9-1F9F-EBCE-E33A-A9A6AB08A2FF}"/>
          </ac:spMkLst>
        </pc:spChg>
        <pc:spChg chg="add mod">
          <ac:chgData name="肇 松島" userId="95d768673f73624d" providerId="LiveId" clId="{4818813B-73AD-2344-8D97-E478523C7736}" dt="2025-04-06T06:06:32.211" v="425" actId="20577"/>
          <ac:spMkLst>
            <pc:docMk/>
            <pc:sldMk cId="91462556" sldId="261"/>
            <ac:spMk id="14" creationId="{50E85048-7C53-F08B-E617-753D508AC3F6}"/>
          </ac:spMkLst>
        </pc:spChg>
        <pc:spChg chg="add mod">
          <ac:chgData name="肇 松島" userId="95d768673f73624d" providerId="LiveId" clId="{4818813B-73AD-2344-8D97-E478523C7736}" dt="2025-04-06T06:06:20.265" v="421" actId="1076"/>
          <ac:spMkLst>
            <pc:docMk/>
            <pc:sldMk cId="91462556" sldId="261"/>
            <ac:spMk id="15" creationId="{C92E951E-CB1C-03A1-9FC5-AC42C28A4621}"/>
          </ac:spMkLst>
        </pc:spChg>
        <pc:spChg chg="add mod">
          <ac:chgData name="肇 松島" userId="95d768673f73624d" providerId="LiveId" clId="{4818813B-73AD-2344-8D97-E478523C7736}" dt="2025-04-06T06:06:20.265" v="421" actId="1076"/>
          <ac:spMkLst>
            <pc:docMk/>
            <pc:sldMk cId="91462556" sldId="261"/>
            <ac:spMk id="16" creationId="{69651942-1368-FA5F-798F-44F5A55983B0}"/>
          </ac:spMkLst>
        </pc:spChg>
        <pc:spChg chg="add mod">
          <ac:chgData name="肇 松島" userId="95d768673f73624d" providerId="LiveId" clId="{4818813B-73AD-2344-8D97-E478523C7736}" dt="2025-04-06T06:06:20.265" v="421" actId="1076"/>
          <ac:spMkLst>
            <pc:docMk/>
            <pc:sldMk cId="91462556" sldId="261"/>
            <ac:spMk id="17" creationId="{65B94268-0C02-B6B2-FF91-51D63969F78A}"/>
          </ac:spMkLst>
        </pc:spChg>
        <pc:picChg chg="add mod">
          <ac:chgData name="肇 松島" userId="95d768673f73624d" providerId="LiveId" clId="{4818813B-73AD-2344-8D97-E478523C7736}" dt="2025-04-06T06:02:46.237" v="402" actId="1036"/>
          <ac:picMkLst>
            <pc:docMk/>
            <pc:sldMk cId="91462556" sldId="261"/>
            <ac:picMk id="5" creationId="{3694F1A6-F7FE-7724-06F8-712C0BEA2BA5}"/>
          </ac:picMkLst>
        </pc:picChg>
        <pc:picChg chg="add mod">
          <ac:chgData name="肇 松島" userId="95d768673f73624d" providerId="LiveId" clId="{4818813B-73AD-2344-8D97-E478523C7736}" dt="2025-04-06T06:02:46.237" v="402" actId="1036"/>
          <ac:picMkLst>
            <pc:docMk/>
            <pc:sldMk cId="91462556" sldId="261"/>
            <ac:picMk id="6" creationId="{1921F504-EEEE-B24B-DDA9-C9950126D0E0}"/>
          </ac:picMkLst>
        </pc:picChg>
        <pc:picChg chg="add mod">
          <ac:chgData name="肇 松島" userId="95d768673f73624d" providerId="LiveId" clId="{4818813B-73AD-2344-8D97-E478523C7736}" dt="2025-04-06T06:06:11.749" v="419" actId="1076"/>
          <ac:picMkLst>
            <pc:docMk/>
            <pc:sldMk cId="91462556" sldId="261"/>
            <ac:picMk id="12" creationId="{900BFB7A-2D94-0D0F-9CE7-918548090262}"/>
          </ac:picMkLst>
        </pc:picChg>
        <pc:picChg chg="add mod">
          <ac:chgData name="肇 松島" userId="95d768673f73624d" providerId="LiveId" clId="{4818813B-73AD-2344-8D97-E478523C7736}" dt="2025-04-06T06:06:20.265" v="421" actId="1076"/>
          <ac:picMkLst>
            <pc:docMk/>
            <pc:sldMk cId="91462556" sldId="261"/>
            <ac:picMk id="13" creationId="{54E99647-4FE0-3C77-5292-495E51783BC1}"/>
          </ac:picMkLst>
        </pc:picChg>
      </pc:sldChg>
      <pc:sldChg chg="addSp delSp modSp new mod">
        <pc:chgData name="肇 松島" userId="95d768673f73624d" providerId="LiveId" clId="{4818813B-73AD-2344-8D97-E478523C7736}" dt="2025-04-10T03:57:07.935" v="531" actId="1076"/>
        <pc:sldMkLst>
          <pc:docMk/>
          <pc:sldMk cId="82209000" sldId="262"/>
        </pc:sldMkLst>
        <pc:spChg chg="del">
          <ac:chgData name="肇 松島" userId="95d768673f73624d" providerId="LiveId" clId="{4818813B-73AD-2344-8D97-E478523C7736}" dt="2025-04-10T03:49:53.968" v="427" actId="478"/>
          <ac:spMkLst>
            <pc:docMk/>
            <pc:sldMk cId="82209000" sldId="262"/>
            <ac:spMk id="2" creationId="{30E94C5D-A569-9112-D3E3-1E44D7384D80}"/>
          </ac:spMkLst>
        </pc:spChg>
        <pc:spChg chg="del">
          <ac:chgData name="肇 松島" userId="95d768673f73624d" providerId="LiveId" clId="{4818813B-73AD-2344-8D97-E478523C7736}" dt="2025-04-10T03:50:15.726" v="432" actId="478"/>
          <ac:spMkLst>
            <pc:docMk/>
            <pc:sldMk cId="82209000" sldId="262"/>
            <ac:spMk id="3" creationId="{6C0FCA70-37A9-F7A9-8D08-09AEA6C059EB}"/>
          </ac:spMkLst>
        </pc:spChg>
        <pc:spChg chg="add mod">
          <ac:chgData name="肇 松島" userId="95d768673f73624d" providerId="LiveId" clId="{4818813B-73AD-2344-8D97-E478523C7736}" dt="2025-04-10T03:57:07.935" v="531" actId="1076"/>
          <ac:spMkLst>
            <pc:docMk/>
            <pc:sldMk cId="82209000" sldId="262"/>
            <ac:spMk id="4" creationId="{128AE043-0FFA-730D-EA3B-836639430FE1}"/>
          </ac:spMkLst>
        </pc:spChg>
        <pc:spChg chg="add mod">
          <ac:chgData name="肇 松島" userId="95d768673f73624d" providerId="LiveId" clId="{4818813B-73AD-2344-8D97-E478523C7736}" dt="2025-04-10T03:56:50.860" v="530" actId="20577"/>
          <ac:spMkLst>
            <pc:docMk/>
            <pc:sldMk cId="82209000" sldId="262"/>
            <ac:spMk id="7" creationId="{21FD9466-9890-2A45-DE6B-0339F181C7E5}"/>
          </ac:spMkLst>
        </pc:spChg>
        <pc:picChg chg="add del">
          <ac:chgData name="肇 松島" userId="95d768673f73624d" providerId="LiveId" clId="{4818813B-73AD-2344-8D97-E478523C7736}" dt="2025-04-10T03:54:14.202" v="434" actId="478"/>
          <ac:picMkLst>
            <pc:docMk/>
            <pc:sldMk cId="82209000" sldId="262"/>
            <ac:picMk id="5" creationId="{FFC94010-3A48-C930-E16E-48B336580413}"/>
          </ac:picMkLst>
        </pc:picChg>
        <pc:picChg chg="add mod modCrop">
          <ac:chgData name="肇 松島" userId="95d768673f73624d" providerId="LiveId" clId="{4818813B-73AD-2344-8D97-E478523C7736}" dt="2025-04-10T03:55:20.032" v="438" actId="1076"/>
          <ac:picMkLst>
            <pc:docMk/>
            <pc:sldMk cId="82209000" sldId="262"/>
            <ac:picMk id="6" creationId="{FBB53309-4EB2-26C2-48E2-1546B3E14A96}"/>
          </ac:picMkLst>
        </pc:picChg>
      </pc:sldChg>
    </pc:docChg>
  </pc:docChgLst>
  <pc:docChgLst>
    <pc:chgData name="肇 松島" userId="95d768673f73624d" providerId="LiveId" clId="{032C1003-BC2E-F349-AF20-271D4704CC87}"/>
    <pc:docChg chg="delSld">
      <pc:chgData name="肇 松島" userId="95d768673f73624d" providerId="LiveId" clId="{032C1003-BC2E-F349-AF20-271D4704CC87}" dt="2025-02-20T09:25:33.895" v="3" actId="2696"/>
      <pc:docMkLst>
        <pc:docMk/>
      </pc:docMkLst>
      <pc:sldChg chg="del">
        <pc:chgData name="肇 松島" userId="95d768673f73624d" providerId="LiveId" clId="{032C1003-BC2E-F349-AF20-271D4704CC87}" dt="2025-02-20T09:25:33.056" v="1" actId="2696"/>
        <pc:sldMkLst>
          <pc:docMk/>
          <pc:sldMk cId="2742235275" sldId="256"/>
        </pc:sldMkLst>
      </pc:sldChg>
      <pc:sldChg chg="del">
        <pc:chgData name="肇 松島" userId="95d768673f73624d" providerId="LiveId" clId="{032C1003-BC2E-F349-AF20-271D4704CC87}" dt="2025-02-20T09:25:33.424" v="2" actId="2696"/>
        <pc:sldMkLst>
          <pc:docMk/>
          <pc:sldMk cId="1142675149" sldId="257"/>
        </pc:sldMkLst>
      </pc:sldChg>
      <pc:sldChg chg="del">
        <pc:chgData name="肇 松島" userId="95d768673f73624d" providerId="LiveId" clId="{032C1003-BC2E-F349-AF20-271D4704CC87}" dt="2025-02-20T09:25:32.654" v="0" actId="2696"/>
        <pc:sldMkLst>
          <pc:docMk/>
          <pc:sldMk cId="986271506" sldId="258"/>
        </pc:sldMkLst>
      </pc:sldChg>
      <pc:sldChg chg="del">
        <pc:chgData name="肇 松島" userId="95d768673f73624d" providerId="LiveId" clId="{032C1003-BC2E-F349-AF20-271D4704CC87}" dt="2025-02-20T09:25:33.895" v="3" actId="2696"/>
        <pc:sldMkLst>
          <pc:docMk/>
          <pc:sldMk cId="2843995754" sldId="260"/>
        </pc:sldMkLst>
      </pc:sldChg>
    </pc:docChg>
  </pc:docChgLst>
  <pc:docChgLst>
    <pc:chgData name="肇 松島" userId="95d768673f73624d" providerId="LiveId" clId="{245FE46D-37DD-5F46-9DB7-CE7E7D202060}"/>
    <pc:docChg chg="modSld">
      <pc:chgData name="肇 松島" userId="95d768673f73624d" providerId="LiveId" clId="{245FE46D-37DD-5F46-9DB7-CE7E7D202060}" dt="2024-09-30T05:06:21.940" v="14" actId="1038"/>
      <pc:docMkLst>
        <pc:docMk/>
      </pc:docMkLst>
      <pc:sldChg chg="modSp mod">
        <pc:chgData name="肇 松島" userId="95d768673f73624d" providerId="LiveId" clId="{245FE46D-37DD-5F46-9DB7-CE7E7D202060}" dt="2024-09-30T05:06:21.940" v="14" actId="1038"/>
        <pc:sldMkLst>
          <pc:docMk/>
          <pc:sldMk cId="986271506" sldId="258"/>
        </pc:sldMkLst>
      </pc:sldChg>
    </pc:docChg>
  </pc:docChgLst>
  <pc:docChgLst>
    <pc:chgData name="肇 松島" userId="95d768673f73624d" providerId="LiveId" clId="{28CA75BF-CCF1-F44A-8399-6207EA31BD18}"/>
    <pc:docChg chg="undo custSel modSld">
      <pc:chgData name="肇 松島" userId="95d768673f73624d" providerId="LiveId" clId="{28CA75BF-CCF1-F44A-8399-6207EA31BD18}" dt="2025-02-20T09:21:56.120" v="129" actId="20577"/>
      <pc:docMkLst>
        <pc:docMk/>
      </pc:docMkLst>
      <pc:sldChg chg="delSp modSp mod">
        <pc:chgData name="肇 松島" userId="95d768673f73624d" providerId="LiveId" clId="{28CA75BF-CCF1-F44A-8399-6207EA31BD18}" dt="2025-02-20T09:18:54.247" v="65" actId="20577"/>
        <pc:sldMkLst>
          <pc:docMk/>
          <pc:sldMk cId="2742235275" sldId="256"/>
        </pc:sldMkLst>
      </pc:sldChg>
      <pc:sldChg chg="modSp mod">
        <pc:chgData name="肇 松島" userId="95d768673f73624d" providerId="LiveId" clId="{28CA75BF-CCF1-F44A-8399-6207EA31BD18}" dt="2025-02-20T09:21:31.776" v="115" actId="20577"/>
        <pc:sldMkLst>
          <pc:docMk/>
          <pc:sldMk cId="1142675149" sldId="257"/>
        </pc:sldMkLst>
      </pc:sldChg>
      <pc:sldChg chg="modSp mod">
        <pc:chgData name="肇 松島" userId="95d768673f73624d" providerId="LiveId" clId="{28CA75BF-CCF1-F44A-8399-6207EA31BD18}" dt="2025-02-20T09:20:35.284" v="92" actId="20577"/>
        <pc:sldMkLst>
          <pc:docMk/>
          <pc:sldMk cId="986271506" sldId="258"/>
        </pc:sldMkLst>
      </pc:sldChg>
      <pc:sldChg chg="modSp mod">
        <pc:chgData name="肇 松島" userId="95d768673f73624d" providerId="LiveId" clId="{28CA75BF-CCF1-F44A-8399-6207EA31BD18}" dt="2025-02-20T09:17:32.325" v="17" actId="20577"/>
        <pc:sldMkLst>
          <pc:docMk/>
          <pc:sldMk cId="821765087" sldId="259"/>
        </pc:sldMkLst>
        <pc:spChg chg="mod">
          <ac:chgData name="肇 松島" userId="95d768673f73624d" providerId="LiveId" clId="{28CA75BF-CCF1-F44A-8399-6207EA31BD18}" dt="2025-02-20T09:17:18.415" v="6" actId="20577"/>
          <ac:spMkLst>
            <pc:docMk/>
            <pc:sldMk cId="821765087" sldId="259"/>
            <ac:spMk id="10" creationId="{C52E6981-3064-5911-6B46-D7FE988E5275}"/>
          </ac:spMkLst>
        </pc:spChg>
        <pc:spChg chg="mod">
          <ac:chgData name="肇 松島" userId="95d768673f73624d" providerId="LiveId" clId="{28CA75BF-CCF1-F44A-8399-6207EA31BD18}" dt="2025-02-20T09:17:22.024" v="9" actId="20577"/>
          <ac:spMkLst>
            <pc:docMk/>
            <pc:sldMk cId="821765087" sldId="259"/>
            <ac:spMk id="11" creationId="{BF15D80D-8DFD-B6CD-2943-1B553EEB2631}"/>
          </ac:spMkLst>
        </pc:spChg>
        <pc:spChg chg="mod">
          <ac:chgData name="肇 松島" userId="95d768673f73624d" providerId="LiveId" clId="{28CA75BF-CCF1-F44A-8399-6207EA31BD18}" dt="2025-02-20T09:17:27.299" v="12" actId="20577"/>
          <ac:spMkLst>
            <pc:docMk/>
            <pc:sldMk cId="821765087" sldId="259"/>
            <ac:spMk id="17" creationId="{1E1AA154-2E1A-10F0-BFC0-33BC52C3CDC4}"/>
          </ac:spMkLst>
        </pc:spChg>
        <pc:spChg chg="mod">
          <ac:chgData name="肇 松島" userId="95d768673f73624d" providerId="LiveId" clId="{28CA75BF-CCF1-F44A-8399-6207EA31BD18}" dt="2025-02-20T09:17:32.325" v="17" actId="20577"/>
          <ac:spMkLst>
            <pc:docMk/>
            <pc:sldMk cId="821765087" sldId="259"/>
            <ac:spMk id="18" creationId="{29385B82-13D4-5FD0-D137-9A5CA4AAFACC}"/>
          </ac:spMkLst>
        </pc:spChg>
      </pc:sldChg>
      <pc:sldChg chg="modSp mod">
        <pc:chgData name="肇 松島" userId="95d768673f73624d" providerId="LiveId" clId="{28CA75BF-CCF1-F44A-8399-6207EA31BD18}" dt="2025-02-20T09:21:56.120" v="129" actId="20577"/>
        <pc:sldMkLst>
          <pc:docMk/>
          <pc:sldMk cId="2843995754" sldId="260"/>
        </pc:sldMkLst>
      </pc:sldChg>
    </pc:docChg>
  </pc:docChgLst>
  <pc:docChgLst>
    <pc:chgData name="肇 松島" userId="95d768673f73624d" providerId="LiveId" clId="{A38CF26F-0F8A-0044-8E1C-379570D42179}"/>
    <pc:docChg chg="modSld">
      <pc:chgData name="肇 松島" userId="95d768673f73624d" providerId="LiveId" clId="{A38CF26F-0F8A-0044-8E1C-379570D42179}" dt="2024-12-04T11:50:58.570" v="0" actId="164"/>
      <pc:docMkLst>
        <pc:docMk/>
      </pc:docMkLst>
      <pc:sldChg chg="addSp modSp">
        <pc:chgData name="肇 松島" userId="95d768673f73624d" providerId="LiveId" clId="{A38CF26F-0F8A-0044-8E1C-379570D42179}" dt="2024-12-04T11:50:58.570" v="0" actId="164"/>
        <pc:sldMkLst>
          <pc:docMk/>
          <pc:sldMk cId="2742235275" sldId="256"/>
        </pc:sldMkLst>
      </pc:sldChg>
    </pc:docChg>
  </pc:docChgLst>
  <pc:docChgLst>
    <pc:chgData name="肇 松島" userId="95d768673f73624d" providerId="LiveId" clId="{6C96ACAC-BEE7-D443-888D-EC59E80F1476}"/>
    <pc:docChg chg="custSel addSld modSld">
      <pc:chgData name="肇 松島" userId="95d768673f73624d" providerId="LiveId" clId="{6C96ACAC-BEE7-D443-888D-EC59E80F1476}" dt="2024-08-31T03:07:15.442" v="1005" actId="478"/>
      <pc:docMkLst>
        <pc:docMk/>
      </pc:docMkLst>
      <pc:sldChg chg="addSp delSp modSp mod">
        <pc:chgData name="肇 松島" userId="95d768673f73624d" providerId="LiveId" clId="{6C96ACAC-BEE7-D443-888D-EC59E80F1476}" dt="2024-08-31T02:43:44.439" v="606" actId="20577"/>
        <pc:sldMkLst>
          <pc:docMk/>
          <pc:sldMk cId="2742235275" sldId="256"/>
        </pc:sldMkLst>
      </pc:sldChg>
      <pc:sldChg chg="addSp delSp modSp mod">
        <pc:chgData name="肇 松島" userId="95d768673f73624d" providerId="LiveId" clId="{6C96ACAC-BEE7-D443-888D-EC59E80F1476}" dt="2024-08-31T02:46:33.143" v="609" actId="478"/>
        <pc:sldMkLst>
          <pc:docMk/>
          <pc:sldMk cId="1142675149" sldId="257"/>
        </pc:sldMkLst>
      </pc:sldChg>
      <pc:sldChg chg="addSp delSp modSp mod">
        <pc:chgData name="肇 松島" userId="95d768673f73624d" providerId="LiveId" clId="{6C96ACAC-BEE7-D443-888D-EC59E80F1476}" dt="2024-08-31T03:07:15.442" v="1005" actId="478"/>
        <pc:sldMkLst>
          <pc:docMk/>
          <pc:sldMk cId="986271506" sldId="258"/>
        </pc:sldMkLst>
      </pc:sldChg>
      <pc:sldChg chg="addSp delSp modSp new mod">
        <pc:chgData name="肇 松島" userId="95d768673f73624d" providerId="LiveId" clId="{6C96ACAC-BEE7-D443-888D-EC59E80F1476}" dt="2024-08-31T03:05:58.509" v="1003" actId="1076"/>
        <pc:sldMkLst>
          <pc:docMk/>
          <pc:sldMk cId="821765087" sldId="25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7112578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29753379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138279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024343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82807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777658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4088431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60865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1624943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347883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US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3062929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B99CE41-C3FC-374E-B042-446AAF2962CC}" type="datetimeFigureOut">
              <a:rPr kumimoji="1" lang="ja-US" altLang="en-US" smtClean="0"/>
              <a:t>4/10/25</a:t>
            </a:fld>
            <a:endParaRPr kumimoji="1" lang="ja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746F7A0-192A-F24D-B1C4-4B2139B60FC7}" type="slidenum">
              <a:rPr kumimoji="1" lang="ja-US" altLang="en-US" smtClean="0"/>
              <a:t>‹#›</a:t>
            </a:fld>
            <a:endParaRPr kumimoji="1" lang="ja-US" altLang="en-US"/>
          </a:p>
        </p:txBody>
      </p:sp>
    </p:spTree>
    <p:extLst>
      <p:ext uri="{BB962C8B-B14F-4D97-AF65-F5344CB8AC3E}">
        <p14:creationId xmlns:p14="http://schemas.microsoft.com/office/powerpoint/2010/main" val="1271962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9306C818-9071-B790-92BF-142B6707E0E8}"/>
              </a:ext>
            </a:extLst>
          </p:cNvPr>
          <p:cNvSpPr txBox="1"/>
          <p:nvPr/>
        </p:nvSpPr>
        <p:spPr>
          <a:xfrm>
            <a:off x="386643" y="428517"/>
            <a:ext cx="634186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Supplementary figure 1. Graft (A) and patient (B) survival after propensity score matching</a:t>
            </a:r>
            <a:endParaRPr kumimoji="1" lang="ja-US" altLang="en-US" sz="1200" b="1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C66F6B9B-0CE7-6BF7-38C0-C97B317C53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2590" y="1106101"/>
            <a:ext cx="4952819" cy="3446974"/>
          </a:xfrm>
          <a:prstGeom prst="rect">
            <a:avLst/>
          </a:prstGeom>
        </p:spPr>
      </p:pic>
      <p:pic>
        <p:nvPicPr>
          <p:cNvPr id="7" name="図 6" descr="図形 が含まれている画像&#10;&#10;自動的に生成された説明">
            <a:extLst>
              <a:ext uri="{FF2B5EF4-FFF2-40B4-BE49-F238E27FC236}">
                <a16:creationId xmlns:a16="http://schemas.microsoft.com/office/drawing/2014/main" id="{6D986703-28A2-2D25-4020-E6B51308975B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314" b="12298"/>
          <a:stretch/>
        </p:blipFill>
        <p:spPr>
          <a:xfrm>
            <a:off x="1851188" y="3124747"/>
            <a:ext cx="260350" cy="445530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0B2DBC-19E6-B593-886F-784FEFE3BD34}"/>
              </a:ext>
            </a:extLst>
          </p:cNvPr>
          <p:cNvSpPr txBox="1"/>
          <p:nvPr/>
        </p:nvSpPr>
        <p:spPr>
          <a:xfrm>
            <a:off x="4727349" y="3583919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</a:t>
            </a:r>
            <a:r>
              <a:rPr kumimoji="1" lang="en-US" altLang="ja-US" sz="1200" dirty="0"/>
              <a:t>= 0.148</a:t>
            </a:r>
            <a:endParaRPr kumimoji="1" lang="ja-US" altLang="en-US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AED8B99-40C2-B008-A029-5276CDDF6C86}"/>
              </a:ext>
            </a:extLst>
          </p:cNvPr>
          <p:cNvSpPr txBox="1"/>
          <p:nvPr/>
        </p:nvSpPr>
        <p:spPr>
          <a:xfrm>
            <a:off x="1710055" y="2805403"/>
            <a:ext cx="2186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Distance from Tx center, miles</a:t>
            </a:r>
            <a:endParaRPr kumimoji="1" lang="ja-US" altLang="en-US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52E6981-3064-5911-6B46-D7FE988E5275}"/>
              </a:ext>
            </a:extLst>
          </p:cNvPr>
          <p:cNvSpPr txBox="1"/>
          <p:nvPr/>
        </p:nvSpPr>
        <p:spPr>
          <a:xfrm>
            <a:off x="2121976" y="3119991"/>
            <a:ext cx="910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1+ 2</a:t>
            </a:r>
            <a:endParaRPr kumimoji="1" lang="ja-US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F15D80D-8DFD-B6CD-2943-1B553EEB2631}"/>
              </a:ext>
            </a:extLst>
          </p:cNvPr>
          <p:cNvSpPr txBox="1"/>
          <p:nvPr/>
        </p:nvSpPr>
        <p:spPr>
          <a:xfrm>
            <a:off x="2111538" y="3372261"/>
            <a:ext cx="714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3</a:t>
            </a:r>
            <a:endParaRPr kumimoji="1" lang="ja-US" altLang="en-US" sz="1200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8F24A40E-BAC9-3B75-B2BD-94332EAF5C3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52588" y="5459880"/>
            <a:ext cx="4952821" cy="3446975"/>
          </a:xfrm>
          <a:prstGeom prst="rect">
            <a:avLst/>
          </a:prstGeom>
        </p:spPr>
      </p:pic>
      <p:pic>
        <p:nvPicPr>
          <p:cNvPr id="14" name="図 13" descr="図形 が含まれている画像&#10;&#10;自動的に生成された説明">
            <a:extLst>
              <a:ext uri="{FF2B5EF4-FFF2-40B4-BE49-F238E27FC236}">
                <a16:creationId xmlns:a16="http://schemas.microsoft.com/office/drawing/2014/main" id="{97DD53F7-B92D-07E5-E784-1E4665A35769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314" b="12298"/>
          <a:stretch/>
        </p:blipFill>
        <p:spPr>
          <a:xfrm>
            <a:off x="1851188" y="7467787"/>
            <a:ext cx="260350" cy="445530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104B0BC-F1D5-D356-D1A3-AB7AEDE4364D}"/>
              </a:ext>
            </a:extLst>
          </p:cNvPr>
          <p:cNvSpPr txBox="1"/>
          <p:nvPr/>
        </p:nvSpPr>
        <p:spPr>
          <a:xfrm>
            <a:off x="4932337" y="7935072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</a:t>
            </a:r>
            <a:r>
              <a:rPr kumimoji="1" lang="en-US" altLang="ja-US" sz="1200" dirty="0"/>
              <a:t>= 0.029</a:t>
            </a:r>
            <a:endParaRPr kumimoji="1" lang="ja-US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FB27835-29C7-68ED-6D94-F2C18096D97F}"/>
              </a:ext>
            </a:extLst>
          </p:cNvPr>
          <p:cNvSpPr txBox="1"/>
          <p:nvPr/>
        </p:nvSpPr>
        <p:spPr>
          <a:xfrm>
            <a:off x="1710055" y="7167899"/>
            <a:ext cx="2186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Distance from Tx center, miles</a:t>
            </a:r>
            <a:endParaRPr kumimoji="1" lang="ja-US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E1AA154-2E1A-10F0-BFC0-33BC52C3CDC4}"/>
              </a:ext>
            </a:extLst>
          </p:cNvPr>
          <p:cNvSpPr txBox="1"/>
          <p:nvPr/>
        </p:nvSpPr>
        <p:spPr>
          <a:xfrm>
            <a:off x="2121976" y="7482487"/>
            <a:ext cx="9103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1+ 2</a:t>
            </a:r>
            <a:endParaRPr kumimoji="1" lang="ja-US" altLang="en-US" sz="1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29385B82-13D4-5FD0-D137-9A5CA4AAFACC}"/>
              </a:ext>
            </a:extLst>
          </p:cNvPr>
          <p:cNvSpPr txBox="1"/>
          <p:nvPr/>
        </p:nvSpPr>
        <p:spPr>
          <a:xfrm>
            <a:off x="2111538" y="7734757"/>
            <a:ext cx="7147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3</a:t>
            </a:r>
            <a:endParaRPr kumimoji="1" lang="ja-US" altLang="en-US" sz="1200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E28D05E-0A2F-866A-5B33-7F4A3C7C2A0F}"/>
              </a:ext>
            </a:extLst>
          </p:cNvPr>
          <p:cNvSpPr txBox="1"/>
          <p:nvPr/>
        </p:nvSpPr>
        <p:spPr>
          <a:xfrm>
            <a:off x="671742" y="779005"/>
            <a:ext cx="280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A</a:t>
            </a:r>
            <a:endParaRPr kumimoji="1" lang="ja-US" altLang="en-US" sz="1200" b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10335EA4-62F2-181A-1180-05F211C27AB3}"/>
              </a:ext>
            </a:extLst>
          </p:cNvPr>
          <p:cNvSpPr txBox="1"/>
          <p:nvPr/>
        </p:nvSpPr>
        <p:spPr>
          <a:xfrm>
            <a:off x="896171" y="4874850"/>
            <a:ext cx="5065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/>
              <a:t>Gr 3            74           59         56            53          52           49            48          44             42           40         36</a:t>
            </a:r>
            <a:endParaRPr kumimoji="1" lang="ja-US" altLang="en-US" sz="10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8F5C8C91-E4B5-13C0-FF8B-C5EDD332FEA5}"/>
              </a:ext>
            </a:extLst>
          </p:cNvPr>
          <p:cNvSpPr txBox="1"/>
          <p:nvPr/>
        </p:nvSpPr>
        <p:spPr>
          <a:xfrm>
            <a:off x="896170" y="4686254"/>
            <a:ext cx="5065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/>
              <a:t>Gr 1+2       74           64         62           59           57           55            54          52            50           49          46</a:t>
            </a:r>
            <a:endParaRPr kumimoji="1" lang="ja-US" altLang="en-US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4EF183D-0879-C798-D525-CFCC94D54B7D}"/>
              </a:ext>
            </a:extLst>
          </p:cNvPr>
          <p:cNvSpPr txBox="1"/>
          <p:nvPr/>
        </p:nvSpPr>
        <p:spPr>
          <a:xfrm>
            <a:off x="537433" y="4448860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000" dirty="0"/>
              <a:t>Number at risk</a:t>
            </a:r>
            <a:endParaRPr kumimoji="1" lang="ja-US" altLang="en-US" sz="1000" dirty="0"/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53A369E-C048-AE02-9558-1D0FF057A07F}"/>
              </a:ext>
            </a:extLst>
          </p:cNvPr>
          <p:cNvSpPr txBox="1"/>
          <p:nvPr/>
        </p:nvSpPr>
        <p:spPr>
          <a:xfrm>
            <a:off x="901923" y="9184288"/>
            <a:ext cx="50656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/>
              <a:t>Gr 3            74           60         56            53          52           49            48          44             42           40         36</a:t>
            </a:r>
            <a:endParaRPr kumimoji="1" lang="ja-US" altLang="en-US" sz="1000" dirty="0"/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E6F2F2DA-2263-50BB-8726-14DFA03552B4}"/>
              </a:ext>
            </a:extLst>
          </p:cNvPr>
          <p:cNvSpPr txBox="1"/>
          <p:nvPr/>
        </p:nvSpPr>
        <p:spPr>
          <a:xfrm>
            <a:off x="901922" y="8995692"/>
            <a:ext cx="5065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US" sz="1000" dirty="0"/>
              <a:t>Gr 1+2       74           66         64           62          60            59            58          55            53           52          50</a:t>
            </a:r>
            <a:endParaRPr kumimoji="1" lang="ja-US" altLang="en-US" sz="1000" dirty="0"/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0F91105-7D8B-6BD6-33A6-EFC3C2B5B60C}"/>
              </a:ext>
            </a:extLst>
          </p:cNvPr>
          <p:cNvSpPr txBox="1"/>
          <p:nvPr/>
        </p:nvSpPr>
        <p:spPr>
          <a:xfrm>
            <a:off x="543185" y="8758298"/>
            <a:ext cx="103586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000" dirty="0"/>
              <a:t>Number at risk</a:t>
            </a:r>
            <a:endParaRPr kumimoji="1" lang="ja-US" altLang="en-US" sz="10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1C32FEC2-8DE6-A7AF-C778-4C906B2B44EB}"/>
              </a:ext>
            </a:extLst>
          </p:cNvPr>
          <p:cNvSpPr txBox="1"/>
          <p:nvPr/>
        </p:nvSpPr>
        <p:spPr>
          <a:xfrm>
            <a:off x="671742" y="5149912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B</a:t>
            </a:r>
            <a:endParaRPr kumimoji="1" lang="ja-US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8217650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41A1ABA-1644-0001-BF14-B7D5A457A067}"/>
              </a:ext>
            </a:extLst>
          </p:cNvPr>
          <p:cNvSpPr txBox="1"/>
          <p:nvPr/>
        </p:nvSpPr>
        <p:spPr>
          <a:xfrm>
            <a:off x="386643" y="428517"/>
            <a:ext cx="59220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Supplementary figure 2 .One-year survival and conditional survival analyses in the </a:t>
            </a:r>
          </a:p>
          <a:p>
            <a:r>
              <a:rPr kumimoji="1" lang="en-US" altLang="en-US" sz="1200" b="1" dirty="0"/>
              <a:t>matched cohort.</a:t>
            </a:r>
            <a:endParaRPr kumimoji="1" lang="ja-US" altLang="en-US" sz="1200" b="1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3694F1A6-F7FE-7724-06F8-712C0BEA2BA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8438" y="1375334"/>
            <a:ext cx="5346700" cy="3721100"/>
          </a:xfrm>
          <a:prstGeom prst="rect">
            <a:avLst/>
          </a:prstGeom>
        </p:spPr>
      </p:pic>
      <p:pic>
        <p:nvPicPr>
          <p:cNvPr id="6" name="図 5" descr="図形 が含まれている画像&#10;&#10;自動的に生成された説明">
            <a:extLst>
              <a:ext uri="{FF2B5EF4-FFF2-40B4-BE49-F238E27FC236}">
                <a16:creationId xmlns:a16="http://schemas.microsoft.com/office/drawing/2014/main" id="{1921F504-EEEE-B24B-DDA9-C9950126D0E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314" b="12298"/>
          <a:stretch/>
        </p:blipFill>
        <p:spPr>
          <a:xfrm>
            <a:off x="1564318" y="3626770"/>
            <a:ext cx="260350" cy="445530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DB7C083-7FEA-7E14-B5A3-B507670FBA9D}"/>
              </a:ext>
            </a:extLst>
          </p:cNvPr>
          <p:cNvSpPr txBox="1"/>
          <p:nvPr/>
        </p:nvSpPr>
        <p:spPr>
          <a:xfrm>
            <a:off x="4440479" y="4085942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</a:t>
            </a:r>
            <a:r>
              <a:rPr kumimoji="1" lang="en-US" altLang="ja-US" sz="1200" dirty="0"/>
              <a:t>= 0.089</a:t>
            </a:r>
            <a:endParaRPr kumimoji="1" lang="ja-US" altLang="en-US" sz="1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2B11CE36-285B-9F83-486A-2F7286E22BB1}"/>
              </a:ext>
            </a:extLst>
          </p:cNvPr>
          <p:cNvSpPr txBox="1"/>
          <p:nvPr/>
        </p:nvSpPr>
        <p:spPr>
          <a:xfrm>
            <a:off x="1423185" y="3307426"/>
            <a:ext cx="2186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Distance from Tx center, miles</a:t>
            </a:r>
            <a:endParaRPr kumimoji="1" lang="ja-US" altLang="en-US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9F8863CA-8F0C-3C26-9B41-C89FB1B35608}"/>
              </a:ext>
            </a:extLst>
          </p:cNvPr>
          <p:cNvSpPr txBox="1"/>
          <p:nvPr/>
        </p:nvSpPr>
        <p:spPr>
          <a:xfrm>
            <a:off x="1835106" y="3622014"/>
            <a:ext cx="13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1+ 2 (n=74)</a:t>
            </a:r>
            <a:endParaRPr kumimoji="1" lang="ja-US" altLang="en-US" sz="1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35C8655-C7F2-E750-CE14-8ACA68D90456}"/>
              </a:ext>
            </a:extLst>
          </p:cNvPr>
          <p:cNvSpPr txBox="1"/>
          <p:nvPr/>
        </p:nvSpPr>
        <p:spPr>
          <a:xfrm>
            <a:off x="1824668" y="3874284"/>
            <a:ext cx="11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3 (n=74)</a:t>
            </a:r>
            <a:endParaRPr kumimoji="1" lang="ja-US" altLang="en-US" sz="1200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D4EF24E9-1F9F-EBCE-E33A-A9A6AB08A2FF}"/>
              </a:ext>
            </a:extLst>
          </p:cNvPr>
          <p:cNvSpPr txBox="1"/>
          <p:nvPr/>
        </p:nvSpPr>
        <p:spPr>
          <a:xfrm>
            <a:off x="2408065" y="1055990"/>
            <a:ext cx="193815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One-year patient survival</a:t>
            </a:r>
            <a:endParaRPr kumimoji="1" lang="ja-US" altLang="en-US" sz="1200" b="1" dirty="0"/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900BFB7A-2D94-0D0F-9CE7-91854809026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8438" y="5726063"/>
            <a:ext cx="5346700" cy="3721100"/>
          </a:xfrm>
          <a:prstGeom prst="rect">
            <a:avLst/>
          </a:prstGeom>
        </p:spPr>
      </p:pic>
      <p:pic>
        <p:nvPicPr>
          <p:cNvPr id="13" name="図 12" descr="図形 が含まれている画像&#10;&#10;自動的に生成された説明">
            <a:extLst>
              <a:ext uri="{FF2B5EF4-FFF2-40B4-BE49-F238E27FC236}">
                <a16:creationId xmlns:a16="http://schemas.microsoft.com/office/drawing/2014/main" id="{54E99647-4FE0-3C77-5292-495E51783BC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22314" b="12298"/>
          <a:stretch/>
        </p:blipFill>
        <p:spPr>
          <a:xfrm>
            <a:off x="1705451" y="7987886"/>
            <a:ext cx="260350" cy="445530"/>
          </a:xfrm>
          <a:prstGeom prst="rect">
            <a:avLst/>
          </a:prstGeom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50E85048-7C53-F08B-E617-753D508AC3F6}"/>
              </a:ext>
            </a:extLst>
          </p:cNvPr>
          <p:cNvSpPr txBox="1"/>
          <p:nvPr/>
        </p:nvSpPr>
        <p:spPr>
          <a:xfrm>
            <a:off x="4581612" y="8447058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</a:t>
            </a:r>
            <a:r>
              <a:rPr kumimoji="1" lang="en-US" altLang="ja-US" sz="1200" dirty="0"/>
              <a:t>= 0.055</a:t>
            </a:r>
            <a:endParaRPr kumimoji="1" lang="ja-US" altLang="en-US" sz="1200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C92E951E-CB1C-03A1-9FC5-AC42C28A4621}"/>
              </a:ext>
            </a:extLst>
          </p:cNvPr>
          <p:cNvSpPr txBox="1"/>
          <p:nvPr/>
        </p:nvSpPr>
        <p:spPr>
          <a:xfrm>
            <a:off x="1564318" y="7668542"/>
            <a:ext cx="2186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Distance from Tx center, miles</a:t>
            </a:r>
            <a:endParaRPr kumimoji="1" lang="ja-US" altLang="en-US" sz="1200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69651942-1368-FA5F-798F-44F5A55983B0}"/>
              </a:ext>
            </a:extLst>
          </p:cNvPr>
          <p:cNvSpPr txBox="1"/>
          <p:nvPr/>
        </p:nvSpPr>
        <p:spPr>
          <a:xfrm>
            <a:off x="1976239" y="7983130"/>
            <a:ext cx="13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1+ 2 (n=74)</a:t>
            </a:r>
            <a:endParaRPr kumimoji="1" lang="ja-US" altLang="en-US" sz="1200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5B94268-0C02-B6B2-FF91-51D63969F78A}"/>
              </a:ext>
            </a:extLst>
          </p:cNvPr>
          <p:cNvSpPr txBox="1"/>
          <p:nvPr/>
        </p:nvSpPr>
        <p:spPr>
          <a:xfrm>
            <a:off x="1965801" y="8235400"/>
            <a:ext cx="11667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3 (n=74)</a:t>
            </a:r>
            <a:endParaRPr kumimoji="1" lang="ja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914625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F3718A0-AD90-2548-BA11-6DD545835CEA}"/>
              </a:ext>
            </a:extLst>
          </p:cNvPr>
          <p:cNvSpPr txBox="1"/>
          <p:nvPr/>
        </p:nvSpPr>
        <p:spPr>
          <a:xfrm>
            <a:off x="386643" y="428517"/>
            <a:ext cx="643887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Supplementary figure 3 .Percentages of patients who were transferred to another hospital </a:t>
            </a:r>
          </a:p>
          <a:p>
            <a:r>
              <a:rPr kumimoji="1" lang="en-US" altLang="ja-US" sz="1200" b="1" dirty="0"/>
              <a:t>after LDLT  </a:t>
            </a:r>
            <a:endParaRPr kumimoji="1" lang="ja-US" altLang="en-US" sz="1200" b="1" dirty="0"/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6E2F5C25-78AE-63CF-1481-46087A792728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8758" t="5237" r="40392" b="65795"/>
          <a:stretch/>
        </p:blipFill>
        <p:spPr>
          <a:xfrm>
            <a:off x="555811" y="1721223"/>
            <a:ext cx="2115671" cy="1586753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43166489-E7D6-8300-C398-CD3D85A9281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8758" t="35268" r="40392" b="35764"/>
          <a:stretch/>
        </p:blipFill>
        <p:spPr>
          <a:xfrm>
            <a:off x="2371164" y="1709793"/>
            <a:ext cx="2115671" cy="1586753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C4087712-D611-84E7-4BD9-B57C2B210ACE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28758" t="65301" r="40392" b="5732"/>
          <a:stretch/>
        </p:blipFill>
        <p:spPr>
          <a:xfrm>
            <a:off x="4186520" y="1698363"/>
            <a:ext cx="2115671" cy="1586753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62C88CF-9782-55C8-168F-09A43141C5DD}"/>
              </a:ext>
            </a:extLst>
          </p:cNvPr>
          <p:cNvSpPr txBox="1"/>
          <p:nvPr/>
        </p:nvSpPr>
        <p:spPr>
          <a:xfrm>
            <a:off x="5244355" y="3614084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</a:t>
            </a:r>
            <a:r>
              <a:rPr kumimoji="1" lang="en-US" altLang="ja-US" sz="1200" dirty="0"/>
              <a:t>= 0.025</a:t>
            </a:r>
            <a:endParaRPr kumimoji="1" lang="ja-US" altLang="en-US" sz="1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36053E2D-118B-C603-F18D-63851875F959}"/>
              </a:ext>
            </a:extLst>
          </p:cNvPr>
          <p:cNvSpPr txBox="1"/>
          <p:nvPr/>
        </p:nvSpPr>
        <p:spPr>
          <a:xfrm>
            <a:off x="730008" y="1634505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19.8%</a:t>
            </a:r>
            <a:endParaRPr kumimoji="1" lang="ja-JP" altLang="en-US" sz="120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BBA674A-BEBD-5DCA-386D-98B9F37E1222}"/>
              </a:ext>
            </a:extLst>
          </p:cNvPr>
          <p:cNvSpPr txBox="1"/>
          <p:nvPr/>
        </p:nvSpPr>
        <p:spPr>
          <a:xfrm>
            <a:off x="2505094" y="1634505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28.0%</a:t>
            </a:r>
            <a:endParaRPr kumimoji="1" lang="ja-JP" altLang="en-US" sz="120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0601D4FB-7DAD-EBF1-8F30-97F0C481B72C}"/>
              </a:ext>
            </a:extLst>
          </p:cNvPr>
          <p:cNvSpPr txBox="1"/>
          <p:nvPr/>
        </p:nvSpPr>
        <p:spPr>
          <a:xfrm>
            <a:off x="4255206" y="1634505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41.5%</a:t>
            </a:r>
            <a:endParaRPr kumimoji="1" lang="ja-JP" altLang="en-US" sz="120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8B9B63C-B782-D1BB-1566-5F961F2DF08F}"/>
              </a:ext>
            </a:extLst>
          </p:cNvPr>
          <p:cNvSpPr txBox="1"/>
          <p:nvPr/>
        </p:nvSpPr>
        <p:spPr>
          <a:xfrm>
            <a:off x="1473983" y="2679574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80.2%</a:t>
            </a:r>
            <a:endParaRPr kumimoji="1" lang="ja-JP" altLang="en-US" sz="120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05B3EA19-36D2-334D-C00B-94D28A873707}"/>
              </a:ext>
            </a:extLst>
          </p:cNvPr>
          <p:cNvSpPr txBox="1"/>
          <p:nvPr/>
        </p:nvSpPr>
        <p:spPr>
          <a:xfrm>
            <a:off x="3289339" y="2679576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72.0%</a:t>
            </a:r>
            <a:endParaRPr kumimoji="1" lang="ja-JP" altLang="en-US" sz="120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19BA9313-1951-EBE2-73C1-7F6B1FF28204}"/>
              </a:ext>
            </a:extLst>
          </p:cNvPr>
          <p:cNvSpPr txBox="1"/>
          <p:nvPr/>
        </p:nvSpPr>
        <p:spPr>
          <a:xfrm>
            <a:off x="5154973" y="2679575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58.5%</a:t>
            </a:r>
            <a:endParaRPr kumimoji="1" lang="ja-JP" altLang="en-US" sz="1200"/>
          </a:p>
        </p:txBody>
      </p:sp>
      <p:cxnSp>
        <p:nvCxnSpPr>
          <p:cNvPr id="16" name="直線コネクタ 15">
            <a:extLst>
              <a:ext uri="{FF2B5EF4-FFF2-40B4-BE49-F238E27FC236}">
                <a16:creationId xmlns:a16="http://schemas.microsoft.com/office/drawing/2014/main" id="{B8E13737-34B4-437E-44F8-99BFD166BA08}"/>
              </a:ext>
            </a:extLst>
          </p:cNvPr>
          <p:cNvCxnSpPr/>
          <p:nvPr/>
        </p:nvCxnSpPr>
        <p:spPr>
          <a:xfrm flipV="1">
            <a:off x="1364147" y="1464048"/>
            <a:ext cx="299922" cy="514350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96F5267-8C86-BE5A-3985-D0FDF44C2B25}"/>
              </a:ext>
            </a:extLst>
          </p:cNvPr>
          <p:cNvSpPr txBox="1"/>
          <p:nvPr/>
        </p:nvSpPr>
        <p:spPr>
          <a:xfrm>
            <a:off x="1514108" y="1143000"/>
            <a:ext cx="225651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Transferred to another hospital </a:t>
            </a:r>
            <a:endParaRPr kumimoji="1" lang="ja-JP" altLang="en-US" sz="1200"/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CE756200-E382-659F-5F3B-9AE001BEECD7}"/>
              </a:ext>
            </a:extLst>
          </p:cNvPr>
          <p:cNvCxnSpPr>
            <a:cxnSpLocks/>
            <a:stCxn id="20" idx="0"/>
          </p:cNvCxnSpPr>
          <p:nvPr/>
        </p:nvCxnSpPr>
        <p:spPr>
          <a:xfrm flipH="1" flipV="1">
            <a:off x="1709208" y="3046094"/>
            <a:ext cx="695075" cy="617998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E41351A-D23B-C270-6145-460A80FDCE68}"/>
              </a:ext>
            </a:extLst>
          </p:cNvPr>
          <p:cNvSpPr txBox="1"/>
          <p:nvPr/>
        </p:nvSpPr>
        <p:spPr>
          <a:xfrm>
            <a:off x="1726373" y="3664092"/>
            <a:ext cx="13558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/>
              <a:t>Discharged home</a:t>
            </a:r>
            <a:endParaRPr kumimoji="1" lang="ja-JP" altLang="en-US" sz="120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A81E9D95-0FAA-81AF-8389-37073524646A}"/>
              </a:ext>
            </a:extLst>
          </p:cNvPr>
          <p:cNvSpPr txBox="1"/>
          <p:nvPr/>
        </p:nvSpPr>
        <p:spPr>
          <a:xfrm>
            <a:off x="4925710" y="3285116"/>
            <a:ext cx="71474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3</a:t>
            </a:r>
            <a:endParaRPr kumimoji="1" lang="ja-US" altLang="en-US" sz="1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41ED828A-615E-D26E-69CA-B2133640B8A8}"/>
              </a:ext>
            </a:extLst>
          </p:cNvPr>
          <p:cNvSpPr txBox="1"/>
          <p:nvPr/>
        </p:nvSpPr>
        <p:spPr>
          <a:xfrm>
            <a:off x="3055876" y="3285115"/>
            <a:ext cx="71474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2</a:t>
            </a:r>
            <a:endParaRPr kumimoji="1" lang="ja-US" altLang="en-US" sz="1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2F69FD8-5DBE-5A23-647B-24AAFF3F5801}"/>
              </a:ext>
            </a:extLst>
          </p:cNvPr>
          <p:cNvSpPr txBox="1"/>
          <p:nvPr/>
        </p:nvSpPr>
        <p:spPr>
          <a:xfrm>
            <a:off x="1186042" y="3285115"/>
            <a:ext cx="714747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US" sz="1200" dirty="0"/>
              <a:t>Group 1</a:t>
            </a:r>
            <a:endParaRPr kumimoji="1" lang="ja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2323119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28AE043-0FFA-730D-EA3B-836639430FE1}"/>
              </a:ext>
            </a:extLst>
          </p:cNvPr>
          <p:cNvSpPr txBox="1"/>
          <p:nvPr/>
        </p:nvSpPr>
        <p:spPr>
          <a:xfrm>
            <a:off x="240627" y="489137"/>
            <a:ext cx="63767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b="1" dirty="0"/>
              <a:t>Supplementary figure 4 . Number of visits to our transplant center per a year after 3 years </a:t>
            </a:r>
          </a:p>
          <a:p>
            <a:r>
              <a:rPr kumimoji="1" lang="en-US" altLang="en-US" sz="1200" b="1" dirty="0"/>
              <a:t>since LDLT</a:t>
            </a:r>
            <a:endParaRPr kumimoji="1" lang="ja-US" altLang="en-US" sz="1200" b="1" dirty="0"/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FBB53309-4EB2-26C2-48E2-1546B3E14A9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r="33333"/>
          <a:stretch/>
        </p:blipFill>
        <p:spPr>
          <a:xfrm>
            <a:off x="986117" y="1087976"/>
            <a:ext cx="4572000" cy="4072447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1FD9466-9890-2A45-DE6B-0339F181C7E5}"/>
              </a:ext>
            </a:extLst>
          </p:cNvPr>
          <p:cNvSpPr txBox="1"/>
          <p:nvPr/>
        </p:nvSpPr>
        <p:spPr>
          <a:xfrm>
            <a:off x="4491965" y="1275293"/>
            <a:ext cx="7922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US" sz="1200" i="1" dirty="0"/>
              <a:t>P &lt;</a:t>
            </a:r>
            <a:r>
              <a:rPr kumimoji="1" lang="en-US" altLang="ja-US" sz="1200" dirty="0"/>
              <a:t> 0.001</a:t>
            </a:r>
            <a:endParaRPr kumimoji="1" lang="ja-US" altLang="en-US" sz="1200" dirty="0"/>
          </a:p>
        </p:txBody>
      </p:sp>
    </p:spTree>
    <p:extLst>
      <p:ext uri="{BB962C8B-B14F-4D97-AF65-F5344CB8AC3E}">
        <p14:creationId xmlns:p14="http://schemas.microsoft.com/office/powerpoint/2010/main" val="822090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3</TotalTime>
  <Words>240</Words>
  <Application>Microsoft Macintosh PowerPoint</Application>
  <PresentationFormat>A4 210 x 297 mm</PresentationFormat>
  <Paragraphs>4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肇 松島</dc:creator>
  <cp:lastModifiedBy>松島　肇</cp:lastModifiedBy>
  <cp:revision>11</cp:revision>
  <dcterms:created xsi:type="dcterms:W3CDTF">2024-08-30T23:18:10Z</dcterms:created>
  <dcterms:modified xsi:type="dcterms:W3CDTF">2025-04-10T03:57:09Z</dcterms:modified>
</cp:coreProperties>
</file>